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12192000" cy="14544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A0FC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168" autoAdjust="0"/>
    <p:restoredTop sz="94660"/>
  </p:normalViewPr>
  <p:slideViewPr>
    <p:cSldViewPr snapToGrid="0">
      <p:cViewPr>
        <p:scale>
          <a:sx n="66" d="100"/>
          <a:sy n="66" d="100"/>
        </p:scale>
        <p:origin x="-427" y="-3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380345"/>
            <a:ext cx="10363200" cy="5063702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7639322"/>
            <a:ext cx="9144000" cy="3511595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zh-TW" altLang="en-US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800490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011810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774369"/>
            <a:ext cx="2628900" cy="12325940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774369"/>
            <a:ext cx="7734300" cy="12325940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683229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941163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3626072"/>
            <a:ext cx="10515600" cy="6050180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9733489"/>
            <a:ext cx="10515600" cy="3181647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880064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871846"/>
            <a:ext cx="5181600" cy="9228463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871846"/>
            <a:ext cx="5181600" cy="9228463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965055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74373"/>
            <a:ext cx="10515600" cy="2811298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565467"/>
            <a:ext cx="5157787" cy="1747380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312847"/>
            <a:ext cx="5157787" cy="7814397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565467"/>
            <a:ext cx="5183188" cy="1747380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312847"/>
            <a:ext cx="5183188" cy="7814397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890732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547781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873520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69645"/>
            <a:ext cx="3932237" cy="3393758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094167"/>
            <a:ext cx="6172200" cy="1033614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363402"/>
            <a:ext cx="3932237" cy="8083743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305980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69645"/>
            <a:ext cx="3932237" cy="3393758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094167"/>
            <a:ext cx="6172200" cy="1033614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363402"/>
            <a:ext cx="3932237" cy="8083743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163638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774373"/>
            <a:ext cx="10515600" cy="281129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871846"/>
            <a:ext cx="10515600" cy="92284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3480762"/>
            <a:ext cx="2743200" cy="774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3480762"/>
            <a:ext cx="4114800" cy="774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3480762"/>
            <a:ext cx="2743200" cy="774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047227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標題 1"/>
          <p:cNvSpPr>
            <a:spLocks noGrp="1"/>
          </p:cNvSpPr>
          <p:nvPr>
            <p:ph type="title"/>
          </p:nvPr>
        </p:nvSpPr>
        <p:spPr>
          <a:xfrm>
            <a:off x="752475" y="468820"/>
            <a:ext cx="10711393" cy="1510454"/>
          </a:xfrm>
        </p:spPr>
        <p:txBody>
          <a:bodyPr>
            <a:normAutofit/>
          </a:bodyPr>
          <a:lstStyle/>
          <a:p>
            <a:r>
              <a:rPr lang="en-US" altLang="zh-TW" sz="2000" b="1" dirty="0">
                <a:latin typeface="+mn-lt"/>
              </a:rPr>
              <a:t>Supplement </a:t>
            </a:r>
            <a:r>
              <a:rPr lang="en-US" altLang="zh-TW" sz="2000" b="1">
                <a:latin typeface="+mn-lt"/>
              </a:rPr>
              <a:t>Table S3</a:t>
            </a:r>
            <a:r>
              <a:rPr lang="en-US" altLang="zh-TW" sz="2000" b="1" dirty="0">
                <a:latin typeface="+mn-lt"/>
              </a:rPr>
              <a:t>. </a:t>
            </a:r>
            <a:r>
              <a:rPr lang="en-US" altLang="zh-TW" sz="2000" dirty="0">
                <a:latin typeface="+mn-lt"/>
              </a:rPr>
              <a:t>Five-year Kaplan–Meier survival analysis of outcomes in non-anemic female patients with stage 3 chronic kidney disease, comparing hazard ratios between (1) the matched cohort excluding gastrointestinal bleeding and (2) the matched cohort without this exclusion.</a:t>
            </a:r>
            <a:endParaRPr lang="zh-TW" altLang="en-US" sz="2000" dirty="0">
              <a:latin typeface="+mn-lt"/>
            </a:endParaRPr>
          </a:p>
        </p:txBody>
      </p:sp>
      <p:graphicFrame>
        <p:nvGraphicFramePr>
          <p:cNvPr id="3" name="內容版面配置區 2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860597022"/>
              </p:ext>
            </p:extLst>
          </p:nvPr>
        </p:nvGraphicFramePr>
        <p:xfrm>
          <a:off x="752475" y="2389188"/>
          <a:ext cx="10515600" cy="79959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81075">
                  <a:extLst>
                    <a:ext uri="{9D8B030D-6E8A-4147-A177-3AD203B41FA5}">
                      <a16:colId xmlns:a16="http://schemas.microsoft.com/office/drawing/2014/main" val="2284537183"/>
                    </a:ext>
                  </a:extLst>
                </a:gridCol>
                <a:gridCol w="1355725">
                  <a:extLst>
                    <a:ext uri="{9D8B030D-6E8A-4147-A177-3AD203B41FA5}">
                      <a16:colId xmlns:a16="http://schemas.microsoft.com/office/drawing/2014/main" val="3525867653"/>
                    </a:ext>
                  </a:extLst>
                </a:gridCol>
                <a:gridCol w="1092200">
                  <a:extLst>
                    <a:ext uri="{9D8B030D-6E8A-4147-A177-3AD203B41FA5}">
                      <a16:colId xmlns:a16="http://schemas.microsoft.com/office/drawing/2014/main" val="3080521663"/>
                    </a:ext>
                  </a:extLst>
                </a:gridCol>
                <a:gridCol w="1095375">
                  <a:extLst>
                    <a:ext uri="{9D8B030D-6E8A-4147-A177-3AD203B41FA5}">
                      <a16:colId xmlns:a16="http://schemas.microsoft.com/office/drawing/2014/main" val="2027051256"/>
                    </a:ext>
                  </a:extLst>
                </a:gridCol>
                <a:gridCol w="1162050">
                  <a:extLst>
                    <a:ext uri="{9D8B030D-6E8A-4147-A177-3AD203B41FA5}">
                      <a16:colId xmlns:a16="http://schemas.microsoft.com/office/drawing/2014/main" val="1743433493"/>
                    </a:ext>
                  </a:extLst>
                </a:gridCol>
                <a:gridCol w="1219200">
                  <a:extLst>
                    <a:ext uri="{9D8B030D-6E8A-4147-A177-3AD203B41FA5}">
                      <a16:colId xmlns:a16="http://schemas.microsoft.com/office/drawing/2014/main" val="1798104099"/>
                    </a:ext>
                  </a:extLst>
                </a:gridCol>
                <a:gridCol w="1066800">
                  <a:extLst>
                    <a:ext uri="{9D8B030D-6E8A-4147-A177-3AD203B41FA5}">
                      <a16:colId xmlns:a16="http://schemas.microsoft.com/office/drawing/2014/main" val="1721462663"/>
                    </a:ext>
                  </a:extLst>
                </a:gridCol>
                <a:gridCol w="1438275">
                  <a:extLst>
                    <a:ext uri="{9D8B030D-6E8A-4147-A177-3AD203B41FA5}">
                      <a16:colId xmlns:a16="http://schemas.microsoft.com/office/drawing/2014/main" val="2966014684"/>
                    </a:ext>
                  </a:extLst>
                </a:gridCol>
                <a:gridCol w="1104900">
                  <a:extLst>
                    <a:ext uri="{9D8B030D-6E8A-4147-A177-3AD203B41FA5}">
                      <a16:colId xmlns:a16="http://schemas.microsoft.com/office/drawing/2014/main" val="396528814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n-lt"/>
                        </a:rPr>
                        <a:t>Exclude GI bleeding</a:t>
                      </a:r>
                    </a:p>
                  </a:txBody>
                  <a:tcPr>
                    <a:solidFill>
                      <a:srgbClr val="2A0F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n-lt"/>
                        </a:rPr>
                        <a:t>Outcomes</a:t>
                      </a:r>
                      <a:endParaRPr lang="zh-TW" altLang="en-US" sz="1200" dirty="0">
                        <a:latin typeface="+mn-lt"/>
                      </a:endParaRPr>
                    </a:p>
                  </a:txBody>
                  <a:tcPr>
                    <a:solidFill>
                      <a:srgbClr val="2A0FC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ohorts</a:t>
                      </a:r>
                      <a:endParaRPr kumimoji="0" lang="zh-TW" altLang="en-US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rgbClr val="2A0F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n-lt"/>
                        </a:rPr>
                        <a:t>Patients </a:t>
                      </a:r>
                    </a:p>
                    <a:p>
                      <a:pPr algn="ctr"/>
                      <a:r>
                        <a:rPr lang="en-US" altLang="zh-TW" sz="1200" dirty="0">
                          <a:latin typeface="+mn-lt"/>
                        </a:rPr>
                        <a:t>in cohort</a:t>
                      </a:r>
                      <a:endParaRPr lang="zh-TW" altLang="en-US" sz="1200" dirty="0">
                        <a:latin typeface="+mn-lt"/>
                      </a:endParaRPr>
                    </a:p>
                  </a:txBody>
                  <a:tcPr>
                    <a:solidFill>
                      <a:srgbClr val="2A0F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n-lt"/>
                        </a:rPr>
                        <a:t> Patients with outcome</a:t>
                      </a:r>
                      <a:endParaRPr lang="zh-TW" altLang="en-US" sz="1200" dirty="0">
                        <a:latin typeface="+mn-lt"/>
                      </a:endParaRPr>
                    </a:p>
                  </a:txBody>
                  <a:tcPr>
                    <a:solidFill>
                      <a:srgbClr val="2A0F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n-lt"/>
                        </a:rPr>
                        <a:t>Survival probability </a:t>
                      </a:r>
                    </a:p>
                    <a:p>
                      <a:pPr algn="ctr"/>
                      <a:r>
                        <a:rPr lang="en-US" altLang="zh-TW" sz="800" dirty="0">
                          <a:latin typeface="+mn-lt"/>
                        </a:rPr>
                        <a:t>at end of time window</a:t>
                      </a:r>
                      <a:endParaRPr lang="zh-TW" altLang="en-US" sz="800" dirty="0">
                        <a:latin typeface="+mn-lt"/>
                      </a:endParaRPr>
                    </a:p>
                  </a:txBody>
                  <a:tcPr>
                    <a:solidFill>
                      <a:srgbClr val="2A0F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n-lt"/>
                        </a:rPr>
                        <a:t>Hazard Ratio</a:t>
                      </a:r>
                      <a:endParaRPr lang="zh-TW" altLang="en-US" sz="1200" dirty="0">
                        <a:latin typeface="+mn-lt"/>
                      </a:endParaRPr>
                    </a:p>
                  </a:txBody>
                  <a:tcPr>
                    <a:solidFill>
                      <a:srgbClr val="2A0FC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95% CI</a:t>
                      </a:r>
                      <a:endParaRPr kumimoji="0" lang="zh-TW" altLang="en-US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rgbClr val="2A0FC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Log-Rank test</a:t>
                      </a:r>
                    </a:p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P value</a:t>
                      </a:r>
                      <a:endParaRPr kumimoji="0" lang="zh-TW" altLang="en-US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rgbClr val="2A0FC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09756325"/>
                  </a:ext>
                </a:extLst>
              </a:tr>
              <a:tr h="370840"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800" b="1" dirty="0"/>
                        <a:t>Yes</a:t>
                      </a:r>
                      <a:endParaRPr lang="zh-TW" altLang="en-US" sz="1800" b="1" dirty="0"/>
                    </a:p>
                  </a:txBody>
                  <a:tcPr anchor="ctr"/>
                </a:tc>
                <a:tc rowSpan="4"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8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All-cause mortality</a:t>
                      </a:r>
                      <a:endParaRPr kumimoji="0" lang="zh-TW" altLang="en-US" sz="1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>
                          <a:latin typeface="+mn-lt"/>
                        </a:rPr>
                        <a:t>+ iron</a:t>
                      </a:r>
                      <a:endParaRPr lang="zh-TW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5,259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115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97.68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1.051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(0.805, 1.371)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0.715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67283148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TW" altLang="en-US" sz="1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/>
                        <a:t>- iron</a:t>
                      </a:r>
                      <a:endParaRPr lang="zh-TW" altLang="en-US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5,225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103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97.81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17184993"/>
                  </a:ext>
                </a:extLst>
              </a:tr>
              <a:tr h="370840"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800" b="1" dirty="0"/>
                        <a:t>No</a:t>
                      </a:r>
                      <a:endParaRPr lang="zh-TW" altLang="en-US" sz="1800" b="1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TW" altLang="en-US" sz="1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>
                          <a:latin typeface="+mn-lt"/>
                        </a:rPr>
                        <a:t>+ iron</a:t>
                      </a:r>
                      <a:endParaRPr lang="zh-TW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6,457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138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97.75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896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0.709, 1.131)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354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275960047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TW" altLang="en-US" sz="1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/>
                        <a:t>- iron</a:t>
                      </a:r>
                      <a:endParaRPr lang="zh-TW" altLang="en-US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6,438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145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97.50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16888025"/>
                  </a:ext>
                </a:extLst>
              </a:tr>
              <a:tr h="370840"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800" b="1" dirty="0"/>
                        <a:t>Yes</a:t>
                      </a:r>
                      <a:endParaRPr lang="zh-TW" altLang="en-US" sz="1800" b="1" dirty="0"/>
                    </a:p>
                  </a:txBody>
                  <a:tcPr anchor="ctr"/>
                </a:tc>
                <a:tc rowSpan="4"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8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MACE</a:t>
                      </a:r>
                      <a:endParaRPr kumimoji="0" lang="zh-TW" altLang="en-US" sz="1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>
                          <a:latin typeface="+mn-lt"/>
                        </a:rPr>
                        <a:t>+ iron</a:t>
                      </a:r>
                      <a:endParaRPr lang="zh-TW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4,197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880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78.00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1.296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(1.173, 1.433)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0.000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45549465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TW" altLang="en-US" sz="1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/>
                        <a:t>- iron</a:t>
                      </a:r>
                      <a:endParaRPr lang="zh-TW" altLang="en-US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4,369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684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82.76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17833673"/>
                  </a:ext>
                </a:extLst>
              </a:tr>
              <a:tr h="370840"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800" b="1" dirty="0"/>
                        <a:t>No</a:t>
                      </a:r>
                      <a:endParaRPr lang="zh-TW" altLang="en-US" sz="1800" b="1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TW" altLang="en-US" sz="1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>
                          <a:latin typeface="+mn-lt"/>
                        </a:rPr>
                        <a:t>+ iron</a:t>
                      </a:r>
                      <a:endParaRPr lang="zh-TW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5,060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1,153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76.25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1.264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(1.159, 1.378)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0.000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57012992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TW" altLang="en-US" sz="1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/>
                        <a:t>- iron</a:t>
                      </a:r>
                      <a:endParaRPr lang="zh-TW" altLang="en-US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5,360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934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80.86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31601739"/>
                  </a:ext>
                </a:extLst>
              </a:tr>
              <a:tr h="370840"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800" b="1" dirty="0"/>
                        <a:t>Yes</a:t>
                      </a:r>
                      <a:endParaRPr lang="zh-TW" altLang="en-US" sz="1800" b="1" dirty="0"/>
                    </a:p>
                  </a:txBody>
                  <a:tcPr anchor="ctr"/>
                </a:tc>
                <a:tc rowSpan="4"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8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AKI</a:t>
                      </a:r>
                      <a:endParaRPr kumimoji="0" lang="zh-TW" altLang="en-US" sz="1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>
                          <a:latin typeface="+mn-lt"/>
                        </a:rPr>
                        <a:t>+ iron</a:t>
                      </a:r>
                      <a:endParaRPr lang="zh-TW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5,255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421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91.45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1.628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(1.392, 1.904)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0.000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044352869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TW" altLang="en-US" sz="1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/>
                        <a:t>- iron</a:t>
                      </a:r>
                      <a:endParaRPr lang="zh-TW" altLang="en-US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5,308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249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94.79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29785182"/>
                  </a:ext>
                </a:extLst>
              </a:tr>
              <a:tr h="370840"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800" b="1" dirty="0"/>
                        <a:t>No</a:t>
                      </a:r>
                      <a:endParaRPr lang="zh-TW" altLang="en-US" sz="1800" b="1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TW" altLang="en-US" sz="1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>
                          <a:latin typeface="+mn-lt"/>
                        </a:rPr>
                        <a:t>+ iron</a:t>
                      </a:r>
                      <a:endParaRPr lang="zh-TW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6,451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574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90.57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1.659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(1.449, 1.899)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0.000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535090127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TW" altLang="en-US" sz="1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/>
                        <a:t>- iron</a:t>
                      </a:r>
                      <a:endParaRPr lang="zh-TW" altLang="en-US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6,514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333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94.34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32560114"/>
                  </a:ext>
                </a:extLst>
              </a:tr>
              <a:tr h="370840"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800" b="1" dirty="0"/>
                        <a:t>Yes</a:t>
                      </a:r>
                      <a:endParaRPr lang="zh-TW" altLang="en-US" sz="1800" b="1" dirty="0"/>
                    </a:p>
                  </a:txBody>
                  <a:tcPr anchor="ctr"/>
                </a:tc>
                <a:tc rowSpan="4"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8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Pneumonia</a:t>
                      </a:r>
                      <a:endParaRPr kumimoji="0" lang="zh-TW" altLang="en-US" sz="1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>
                          <a:latin typeface="+mn-lt"/>
                        </a:rPr>
                        <a:t>+ iron</a:t>
                      </a:r>
                      <a:endParaRPr lang="zh-TW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5,121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309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93.58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1.512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(1.265, 1.808)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0.000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871051145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TW" altLang="en-US" sz="1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/>
                        <a:t>- iron</a:t>
                      </a:r>
                      <a:endParaRPr lang="zh-TW" altLang="en-US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5,195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198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95.73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44729549"/>
                  </a:ext>
                </a:extLst>
              </a:tr>
              <a:tr h="370840"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800" b="1" dirty="0"/>
                        <a:t>No</a:t>
                      </a:r>
                      <a:endParaRPr lang="zh-TW" altLang="en-US" sz="1800" b="1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TW" altLang="en-US" sz="1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>
                          <a:latin typeface="+mn-lt"/>
                        </a:rPr>
                        <a:t>+ iron</a:t>
                      </a:r>
                      <a:endParaRPr lang="zh-TW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6,287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419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92.96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1.438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(1.236, 1.673)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0.000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699745977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TW" altLang="en-US" sz="1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/>
                        <a:t>- iron</a:t>
                      </a:r>
                      <a:endParaRPr lang="zh-TW" altLang="en-US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6,357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281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95.13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38870206"/>
                  </a:ext>
                </a:extLst>
              </a:tr>
              <a:tr h="370840"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800" b="1" dirty="0"/>
                        <a:t>Yes</a:t>
                      </a:r>
                      <a:endParaRPr lang="zh-TW" altLang="en-US" sz="1800" b="1" dirty="0"/>
                    </a:p>
                  </a:txBody>
                  <a:tcPr anchor="ctr"/>
                </a:tc>
                <a:tc rowSpan="4"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8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GFR &lt; 30 ml/min</a:t>
                      </a:r>
                      <a:endParaRPr kumimoji="0" lang="zh-TW" altLang="en-US" sz="1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>
                          <a:latin typeface="+mn-lt"/>
                        </a:rPr>
                        <a:t>+ iron</a:t>
                      </a:r>
                      <a:endParaRPr lang="zh-TW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5,135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478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90.14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1.333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(1.161, 1.531)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0.000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14666138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TW" altLang="en-US" sz="1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/>
                        <a:t>- iron</a:t>
                      </a:r>
                      <a:endParaRPr lang="zh-TW" altLang="en-US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5,185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348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92.54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07797721"/>
                  </a:ext>
                </a:extLst>
              </a:tr>
              <a:tr h="370840"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800" b="1" dirty="0"/>
                        <a:t>No</a:t>
                      </a:r>
                      <a:endParaRPr lang="zh-TW" altLang="en-US" sz="1800" b="1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TW" altLang="en-US" sz="1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>
                          <a:latin typeface="+mn-lt"/>
                        </a:rPr>
                        <a:t>+ iron</a:t>
                      </a:r>
                      <a:endParaRPr lang="zh-TW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6,294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603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89.92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1.356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(1.198, 1.534)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0.000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274465577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TW" altLang="en-US" sz="1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/>
                        <a:t>- iron</a:t>
                      </a:r>
                      <a:endParaRPr lang="zh-TW" altLang="en-US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6,361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431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92.56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993517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618310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1</TotalTime>
  <Words>286</Words>
  <Application>Microsoft Office PowerPoint</Application>
  <PresentationFormat>Custom</PresentationFormat>
  <Paragraphs>13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佈景主題</vt:lpstr>
      <vt:lpstr>Supplement Table S3. Five-year Kaplan–Meier survival analysis of outcomes in non-anemic female patients with stage 3 chronic kidney disease, comparing hazard ratios between (1) the matched cohort excluding gastrointestinal bleeding and (2) the matched cohort without this exclusion.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Kuo-Cheng</dc:creator>
  <cp:lastModifiedBy>MDPI</cp:lastModifiedBy>
  <cp:revision>16</cp:revision>
  <dcterms:created xsi:type="dcterms:W3CDTF">2025-05-24T08:40:56Z</dcterms:created>
  <dcterms:modified xsi:type="dcterms:W3CDTF">2025-08-07T10:02:22Z</dcterms:modified>
</cp:coreProperties>
</file>